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7" r:id="rId2"/>
    <p:sldId id="258" r:id="rId3"/>
    <p:sldId id="259" r:id="rId4"/>
    <p:sldId id="260" r:id="rId5"/>
    <p:sldId id="264" r:id="rId6"/>
    <p:sldId id="262" r:id="rId7"/>
    <p:sldId id="261" r:id="rId8"/>
    <p:sldId id="293" r:id="rId9"/>
    <p:sldId id="267" r:id="rId10"/>
    <p:sldId id="294" r:id="rId11"/>
    <p:sldId id="268" r:id="rId12"/>
    <p:sldId id="266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0127" autoAdjust="0"/>
  </p:normalViewPr>
  <p:slideViewPr>
    <p:cSldViewPr snapToGrid="0">
      <p:cViewPr varScale="1">
        <p:scale>
          <a:sx n="91" d="100"/>
          <a:sy n="91" d="100"/>
        </p:scale>
        <p:origin x="96" y="6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2" Type="http://schemas.openxmlformats.org/officeDocument/2006/relationships/image" Target="../media/image37.emf"/><Relationship Id="rId1" Type="http://schemas.openxmlformats.org/officeDocument/2006/relationships/image" Target="../media/image36.emf"/><Relationship Id="rId6" Type="http://schemas.openxmlformats.org/officeDocument/2006/relationships/image" Target="../media/image41.emf"/><Relationship Id="rId5" Type="http://schemas.openxmlformats.org/officeDocument/2006/relationships/image" Target="../media/image40.emf"/><Relationship Id="rId4" Type="http://schemas.openxmlformats.org/officeDocument/2006/relationships/image" Target="../media/image39.emf"/></Relationships>
</file>

<file path=ppt/drawings/_rels/vmlDrawing1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2.emf"/></Relationships>
</file>

<file path=ppt/drawings/_rels/vmlDrawing12.vml.rels><?xml version="1.0" encoding="UTF-8" standalone="yes"?>
<Relationships xmlns="http://schemas.openxmlformats.org/package/2006/relationships"><Relationship Id="rId3" Type="http://schemas.openxmlformats.org/officeDocument/2006/relationships/image" Target="../media/image46.emf"/><Relationship Id="rId2" Type="http://schemas.openxmlformats.org/officeDocument/2006/relationships/image" Target="../media/image45.emf"/><Relationship Id="rId1" Type="http://schemas.openxmlformats.org/officeDocument/2006/relationships/image" Target="../media/image44.emf"/><Relationship Id="rId6" Type="http://schemas.openxmlformats.org/officeDocument/2006/relationships/image" Target="../media/image49.emf"/><Relationship Id="rId5" Type="http://schemas.openxmlformats.org/officeDocument/2006/relationships/image" Target="../media/image48.emf"/><Relationship Id="rId4" Type="http://schemas.openxmlformats.org/officeDocument/2006/relationships/image" Target="../media/image47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wmf"/><Relationship Id="rId2" Type="http://schemas.openxmlformats.org/officeDocument/2006/relationships/image" Target="../media/image5.wmf"/><Relationship Id="rId1" Type="http://schemas.openxmlformats.org/officeDocument/2006/relationships/image" Target="../media/image4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12" Type="http://schemas.openxmlformats.org/officeDocument/2006/relationships/image" Target="../media/image19.emf"/><Relationship Id="rId2" Type="http://schemas.openxmlformats.org/officeDocument/2006/relationships/image" Target="../media/image9.emf"/><Relationship Id="rId1" Type="http://schemas.openxmlformats.org/officeDocument/2006/relationships/image" Target="../media/image8.emf"/><Relationship Id="rId6" Type="http://schemas.openxmlformats.org/officeDocument/2006/relationships/image" Target="../media/image13.emf"/><Relationship Id="rId11" Type="http://schemas.openxmlformats.org/officeDocument/2006/relationships/image" Target="../media/image18.emf"/><Relationship Id="rId5" Type="http://schemas.openxmlformats.org/officeDocument/2006/relationships/image" Target="../media/image12.emf"/><Relationship Id="rId10" Type="http://schemas.openxmlformats.org/officeDocument/2006/relationships/image" Target="../media/image17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image" Target="../media/image20.e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image" Target="../media/image22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image" Target="../media/image24.emf"/><Relationship Id="rId4" Type="http://schemas.openxmlformats.org/officeDocument/2006/relationships/image" Target="../media/image27.emf"/></Relationships>
</file>

<file path=ppt/drawings/_rels/vmlDrawing8.v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image" Target="../media/image28.emf"/><Relationship Id="rId6" Type="http://schemas.openxmlformats.org/officeDocument/2006/relationships/image" Target="../media/image33.emf"/><Relationship Id="rId5" Type="http://schemas.openxmlformats.org/officeDocument/2006/relationships/image" Target="../media/image32.emf"/><Relationship Id="rId4" Type="http://schemas.openxmlformats.org/officeDocument/2006/relationships/image" Target="../media/image31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3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638FAA-F192-42AE-8746-9335726E13EF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5C7696-2C49-4259-92C3-880CC57D47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7274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5C7696-2C49-4259-92C3-880CC57D478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7978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5C7696-2C49-4259-92C3-880CC57D4787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1896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5C7696-2C49-4259-92C3-880CC57D4787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81641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AD623E-91B7-4CE6-9829-F64CA3C13760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3632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9CA75-7C04-4092-AD67-3592BDD95FAA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DA7BE-EB98-4F31-ACEB-5EDB3A044F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712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9CA75-7C04-4092-AD67-3592BDD95FAA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DA7BE-EB98-4F31-ACEB-5EDB3A044F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633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9CA75-7C04-4092-AD67-3592BDD95FAA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DA7BE-EB98-4F31-ACEB-5EDB3A044F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442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9CA75-7C04-4092-AD67-3592BDD95FAA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DA7BE-EB98-4F31-ACEB-5EDB3A044F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730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9CA75-7C04-4092-AD67-3592BDD95FAA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DA7BE-EB98-4F31-ACEB-5EDB3A044F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149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9CA75-7C04-4092-AD67-3592BDD95FAA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DA7BE-EB98-4F31-ACEB-5EDB3A044F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837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9CA75-7C04-4092-AD67-3592BDD95FAA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DA7BE-EB98-4F31-ACEB-5EDB3A044F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588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9CA75-7C04-4092-AD67-3592BDD95FAA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DA7BE-EB98-4F31-ACEB-5EDB3A044F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0103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9CA75-7C04-4092-AD67-3592BDD95FAA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DA7BE-EB98-4F31-ACEB-5EDB3A044F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69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9CA75-7C04-4092-AD67-3592BDD95FAA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DA7BE-EB98-4F31-ACEB-5EDB3A044F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565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9CA75-7C04-4092-AD67-3592BDD95FAA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DA7BE-EB98-4F31-ACEB-5EDB3A044F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733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F9CA75-7C04-4092-AD67-3592BDD95FAA}" type="datetimeFigureOut">
              <a:rPr lang="en-US" smtClean="0"/>
              <a:t>4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8DA7BE-EB98-4F31-ACEB-5EDB3A044F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62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7.bin"/><Relationship Id="rId13" Type="http://schemas.openxmlformats.org/officeDocument/2006/relationships/image" Target="../media/image40.emf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37.emf"/><Relationship Id="rId12" Type="http://schemas.openxmlformats.org/officeDocument/2006/relationships/oleObject" Target="../embeddings/oleObject3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6" Type="http://schemas.openxmlformats.org/officeDocument/2006/relationships/oleObject" Target="../embeddings/oleObject36.bin"/><Relationship Id="rId11" Type="http://schemas.openxmlformats.org/officeDocument/2006/relationships/image" Target="../media/image39.emf"/><Relationship Id="rId5" Type="http://schemas.openxmlformats.org/officeDocument/2006/relationships/image" Target="../media/image36.emf"/><Relationship Id="rId15" Type="http://schemas.openxmlformats.org/officeDocument/2006/relationships/image" Target="../media/image41.emf"/><Relationship Id="rId10" Type="http://schemas.openxmlformats.org/officeDocument/2006/relationships/oleObject" Target="../embeddings/oleObject38.bin"/><Relationship Id="rId4" Type="http://schemas.openxmlformats.org/officeDocument/2006/relationships/oleObject" Target="../embeddings/oleObject35.bin"/><Relationship Id="rId9" Type="http://schemas.openxmlformats.org/officeDocument/2006/relationships/image" Target="../media/image38.emf"/><Relationship Id="rId14" Type="http://schemas.openxmlformats.org/officeDocument/2006/relationships/oleObject" Target="../embeddings/oleObject40.bin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1.vml"/><Relationship Id="rId6" Type="http://schemas.openxmlformats.org/officeDocument/2006/relationships/image" Target="../media/image43.jpeg"/><Relationship Id="rId5" Type="http://schemas.openxmlformats.org/officeDocument/2006/relationships/image" Target="../media/image42.emf"/><Relationship Id="rId4" Type="http://schemas.openxmlformats.org/officeDocument/2006/relationships/oleObject" Target="../embeddings/oleObject41.bin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4.bin"/><Relationship Id="rId13" Type="http://schemas.openxmlformats.org/officeDocument/2006/relationships/image" Target="../media/image48.emf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45.emf"/><Relationship Id="rId12" Type="http://schemas.openxmlformats.org/officeDocument/2006/relationships/oleObject" Target="../embeddings/oleObject4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2.vml"/><Relationship Id="rId6" Type="http://schemas.openxmlformats.org/officeDocument/2006/relationships/oleObject" Target="../embeddings/oleObject43.bin"/><Relationship Id="rId11" Type="http://schemas.openxmlformats.org/officeDocument/2006/relationships/image" Target="../media/image47.emf"/><Relationship Id="rId5" Type="http://schemas.openxmlformats.org/officeDocument/2006/relationships/image" Target="../media/image44.emf"/><Relationship Id="rId15" Type="http://schemas.openxmlformats.org/officeDocument/2006/relationships/image" Target="../media/image49.emf"/><Relationship Id="rId10" Type="http://schemas.openxmlformats.org/officeDocument/2006/relationships/oleObject" Target="../embeddings/oleObject45.bin"/><Relationship Id="rId4" Type="http://schemas.openxmlformats.org/officeDocument/2006/relationships/oleObject" Target="../embeddings/oleObject42.bin"/><Relationship Id="rId9" Type="http://schemas.openxmlformats.org/officeDocument/2006/relationships/image" Target="../media/image46.emf"/><Relationship Id="rId14" Type="http://schemas.openxmlformats.org/officeDocument/2006/relationships/oleObject" Target="../embeddings/oleObject47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w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w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13" Type="http://schemas.openxmlformats.org/officeDocument/2006/relationships/oleObject" Target="../embeddings/oleObject13.bin"/><Relationship Id="rId18" Type="http://schemas.openxmlformats.org/officeDocument/2006/relationships/image" Target="../media/image15.emf"/><Relationship Id="rId26" Type="http://schemas.openxmlformats.org/officeDocument/2006/relationships/image" Target="../media/image19.emf"/><Relationship Id="rId3" Type="http://schemas.openxmlformats.org/officeDocument/2006/relationships/oleObject" Target="../embeddings/oleObject8.bin"/><Relationship Id="rId21" Type="http://schemas.openxmlformats.org/officeDocument/2006/relationships/oleObject" Target="../embeddings/oleObject17.bin"/><Relationship Id="rId7" Type="http://schemas.openxmlformats.org/officeDocument/2006/relationships/oleObject" Target="../embeddings/oleObject10.bin"/><Relationship Id="rId12" Type="http://schemas.openxmlformats.org/officeDocument/2006/relationships/image" Target="../media/image12.emf"/><Relationship Id="rId17" Type="http://schemas.openxmlformats.org/officeDocument/2006/relationships/oleObject" Target="../embeddings/oleObject15.bin"/><Relationship Id="rId25" Type="http://schemas.openxmlformats.org/officeDocument/2006/relationships/oleObject" Target="../embeddings/oleObject19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4.emf"/><Relationship Id="rId20" Type="http://schemas.openxmlformats.org/officeDocument/2006/relationships/image" Target="../media/image16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9.emf"/><Relationship Id="rId11" Type="http://schemas.openxmlformats.org/officeDocument/2006/relationships/oleObject" Target="../embeddings/oleObject12.bin"/><Relationship Id="rId24" Type="http://schemas.openxmlformats.org/officeDocument/2006/relationships/image" Target="../media/image18.emf"/><Relationship Id="rId5" Type="http://schemas.openxmlformats.org/officeDocument/2006/relationships/oleObject" Target="../embeddings/oleObject9.bin"/><Relationship Id="rId15" Type="http://schemas.openxmlformats.org/officeDocument/2006/relationships/oleObject" Target="../embeddings/oleObject14.bin"/><Relationship Id="rId23" Type="http://schemas.openxmlformats.org/officeDocument/2006/relationships/oleObject" Target="../embeddings/oleObject18.bin"/><Relationship Id="rId10" Type="http://schemas.openxmlformats.org/officeDocument/2006/relationships/image" Target="../media/image11.emf"/><Relationship Id="rId19" Type="http://schemas.openxmlformats.org/officeDocument/2006/relationships/oleObject" Target="../embeddings/oleObject16.bin"/><Relationship Id="rId4" Type="http://schemas.openxmlformats.org/officeDocument/2006/relationships/image" Target="../media/image8.emf"/><Relationship Id="rId9" Type="http://schemas.openxmlformats.org/officeDocument/2006/relationships/oleObject" Target="../embeddings/oleObject11.bin"/><Relationship Id="rId14" Type="http://schemas.openxmlformats.org/officeDocument/2006/relationships/image" Target="../media/image13.emf"/><Relationship Id="rId22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1.emf"/><Relationship Id="rId5" Type="http://schemas.openxmlformats.org/officeDocument/2006/relationships/oleObject" Target="../embeddings/oleObject21.bin"/><Relationship Id="rId4" Type="http://schemas.openxmlformats.org/officeDocument/2006/relationships/image" Target="../media/image20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23.emf"/><Relationship Id="rId5" Type="http://schemas.openxmlformats.org/officeDocument/2006/relationships/oleObject" Target="../embeddings/oleObject23.bin"/><Relationship Id="rId4" Type="http://schemas.openxmlformats.org/officeDocument/2006/relationships/image" Target="../media/image22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3" Type="http://schemas.openxmlformats.org/officeDocument/2006/relationships/oleObject" Target="../embeddings/oleObject24.bin"/><Relationship Id="rId7" Type="http://schemas.openxmlformats.org/officeDocument/2006/relationships/oleObject" Target="../embeddings/oleObject2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25.emf"/><Relationship Id="rId5" Type="http://schemas.openxmlformats.org/officeDocument/2006/relationships/oleObject" Target="../embeddings/oleObject25.bin"/><Relationship Id="rId10" Type="http://schemas.openxmlformats.org/officeDocument/2006/relationships/image" Target="../media/image27.emf"/><Relationship Id="rId4" Type="http://schemas.openxmlformats.org/officeDocument/2006/relationships/image" Target="../media/image24.emf"/><Relationship Id="rId9" Type="http://schemas.openxmlformats.org/officeDocument/2006/relationships/oleObject" Target="../embeddings/oleObject27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0.bin"/><Relationship Id="rId13" Type="http://schemas.openxmlformats.org/officeDocument/2006/relationships/image" Target="../media/image32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9.emf"/><Relationship Id="rId12" Type="http://schemas.openxmlformats.org/officeDocument/2006/relationships/oleObject" Target="../embeddings/oleObject3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8.vml"/><Relationship Id="rId6" Type="http://schemas.openxmlformats.org/officeDocument/2006/relationships/oleObject" Target="../embeddings/oleObject29.bin"/><Relationship Id="rId11" Type="http://schemas.openxmlformats.org/officeDocument/2006/relationships/image" Target="../media/image31.emf"/><Relationship Id="rId5" Type="http://schemas.openxmlformats.org/officeDocument/2006/relationships/image" Target="../media/image28.emf"/><Relationship Id="rId15" Type="http://schemas.openxmlformats.org/officeDocument/2006/relationships/image" Target="../media/image33.emf"/><Relationship Id="rId10" Type="http://schemas.openxmlformats.org/officeDocument/2006/relationships/oleObject" Target="../embeddings/oleObject31.bin"/><Relationship Id="rId4" Type="http://schemas.openxmlformats.org/officeDocument/2006/relationships/oleObject" Target="../embeddings/oleObject28.bin"/><Relationship Id="rId9" Type="http://schemas.openxmlformats.org/officeDocument/2006/relationships/image" Target="../media/image30.emf"/><Relationship Id="rId14" Type="http://schemas.openxmlformats.org/officeDocument/2006/relationships/oleObject" Target="../embeddings/oleObject33.bin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jpe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9.vml"/><Relationship Id="rId5" Type="http://schemas.openxmlformats.org/officeDocument/2006/relationships/image" Target="../media/image34.emf"/><Relationship Id="rId4" Type="http://schemas.openxmlformats.org/officeDocument/2006/relationships/oleObject" Target="../embeddings/oleObject3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6819" y="196313"/>
            <a:ext cx="3257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upplementary Figure 1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ADA2429-B95A-4315-A595-29918CCE26C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190885" y="2681288"/>
          <a:ext cx="3441700" cy="3263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7" name="Prism 8" r:id="rId3" imgW="3441809" imgH="3264423" progId="Prism8.Document">
                  <p:embed/>
                </p:oleObj>
              </mc:Choice>
              <mc:Fallback>
                <p:oleObj name="Prism 8" r:id="rId3" imgW="3441809" imgH="326442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90885" y="2681288"/>
                        <a:ext cx="3441700" cy="3263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A229D77F-110B-4D85-9C71-4C6236B32D3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756525" y="2682875"/>
          <a:ext cx="3441700" cy="3263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8" name="Prism 8" r:id="rId5" imgW="3441809" imgH="3264423" progId="Prism8.Document">
                  <p:embed/>
                </p:oleObj>
              </mc:Choice>
              <mc:Fallback>
                <p:oleObj name="Prism 8" r:id="rId5" imgW="3441809" imgH="326442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756525" y="2682875"/>
                        <a:ext cx="3441700" cy="3263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DE9A9BA9-38AF-40F1-8A8C-063694E2131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55613" y="2759075"/>
          <a:ext cx="3441700" cy="3263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9" name="Prism 8" r:id="rId7" imgW="3441809" imgH="3264423" progId="Prism8.Document">
                  <p:embed/>
                </p:oleObj>
              </mc:Choice>
              <mc:Fallback>
                <p:oleObj name="Prism 8" r:id="rId7" imgW="3441809" imgH="326442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5613" y="2759075"/>
                        <a:ext cx="3441700" cy="3263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105464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7337098"/>
              </p:ext>
            </p:extLst>
          </p:nvPr>
        </p:nvGraphicFramePr>
        <p:xfrm>
          <a:off x="341110" y="762526"/>
          <a:ext cx="3860800" cy="2713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58" name="Prism 9" r:id="rId4" imgW="3860295" imgH="2698634" progId="Prism9.Document">
                  <p:embed/>
                </p:oleObj>
              </mc:Choice>
              <mc:Fallback>
                <p:oleObj name="Prism 9" r:id="rId4" imgW="3860295" imgH="2698634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1110" y="762526"/>
                        <a:ext cx="3860800" cy="2713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6860950"/>
              </p:ext>
            </p:extLst>
          </p:nvPr>
        </p:nvGraphicFramePr>
        <p:xfrm>
          <a:off x="300687" y="3717395"/>
          <a:ext cx="3860800" cy="269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59" name="Prism 9" r:id="rId6" imgW="3860295" imgH="2698634" progId="Prism9.Document">
                  <p:embed/>
                </p:oleObj>
              </mc:Choice>
              <mc:Fallback>
                <p:oleObj name="Prism 9" r:id="rId6" imgW="3860295" imgH="2698634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00687" y="3717395"/>
                        <a:ext cx="3860800" cy="269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3517045"/>
              </p:ext>
            </p:extLst>
          </p:nvPr>
        </p:nvGraphicFramePr>
        <p:xfrm>
          <a:off x="3960813" y="3709988"/>
          <a:ext cx="3860800" cy="269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60" name="Prism 9" r:id="rId8" imgW="3860295" imgH="2698634" progId="Prism9.Document">
                  <p:embed/>
                </p:oleObj>
              </mc:Choice>
              <mc:Fallback>
                <p:oleObj name="Prism 9" r:id="rId8" imgW="3860295" imgH="2698634" progId="Prism9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960813" y="3709988"/>
                        <a:ext cx="3860800" cy="269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3791775"/>
              </p:ext>
            </p:extLst>
          </p:nvPr>
        </p:nvGraphicFramePr>
        <p:xfrm>
          <a:off x="7992532" y="3717395"/>
          <a:ext cx="3860800" cy="269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61" name="Prism 9" r:id="rId10" imgW="3860295" imgH="2698634" progId="Prism9.Document">
                  <p:embed/>
                </p:oleObj>
              </mc:Choice>
              <mc:Fallback>
                <p:oleObj name="Prism 9" r:id="rId10" imgW="3860295" imgH="2698634" progId="Prism9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7992532" y="3717395"/>
                        <a:ext cx="3860800" cy="269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6F4CE8BC-E108-492F-BD07-4F1443671E89}"/>
              </a:ext>
            </a:extLst>
          </p:cNvPr>
          <p:cNvSpPr txBox="1"/>
          <p:nvPr/>
        </p:nvSpPr>
        <p:spPr>
          <a:xfrm>
            <a:off x="980831" y="865852"/>
            <a:ext cx="1224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r</a:t>
            </a:r>
            <a:r>
              <a:rPr lang="en-US" sz="1400" b="1" baseline="30000" dirty="0"/>
              <a:t>2</a:t>
            </a:r>
            <a:r>
              <a:rPr lang="en-US" sz="1400" b="1" dirty="0"/>
              <a:t> = 0.1681</a:t>
            </a:r>
          </a:p>
          <a:p>
            <a:r>
              <a:rPr lang="en-US" sz="1400" b="1" dirty="0"/>
              <a:t>p =  0.0726</a:t>
            </a:r>
          </a:p>
        </p:txBody>
      </p:sp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55E15FB6-82B8-41F3-AA7E-C2A867A2D3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0066622"/>
              </p:ext>
            </p:extLst>
          </p:nvPr>
        </p:nvGraphicFramePr>
        <p:xfrm>
          <a:off x="3934898" y="762526"/>
          <a:ext cx="3860800" cy="2713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62" name="Prism 9" r:id="rId12" imgW="3860295" imgH="2698634" progId="Prism9.Document">
                  <p:embed/>
                </p:oleObj>
              </mc:Choice>
              <mc:Fallback>
                <p:oleObj name="Prism 9" r:id="rId12" imgW="3860295" imgH="2698634" progId="Prism9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55E15FB6-82B8-41F3-AA7E-C2A867A2D3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934898" y="762526"/>
                        <a:ext cx="3860800" cy="2713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E69D1CB1-6315-43B0-A017-5A5414921C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4388109"/>
              </p:ext>
            </p:extLst>
          </p:nvPr>
        </p:nvGraphicFramePr>
        <p:xfrm>
          <a:off x="8014039" y="762526"/>
          <a:ext cx="3860800" cy="2713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63" name="Prism 9" r:id="rId14" imgW="3860295" imgH="2698634" progId="Prism9.Document">
                  <p:embed/>
                </p:oleObj>
              </mc:Choice>
              <mc:Fallback>
                <p:oleObj name="Prism 9" r:id="rId14" imgW="3860295" imgH="2698634" progId="Prism9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E69D1CB1-6315-43B0-A017-5A5414921CE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8014039" y="762526"/>
                        <a:ext cx="3860800" cy="2713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6F4CE8BC-E108-492F-BD07-4F1443671E89}"/>
              </a:ext>
            </a:extLst>
          </p:cNvPr>
          <p:cNvSpPr txBox="1"/>
          <p:nvPr/>
        </p:nvSpPr>
        <p:spPr>
          <a:xfrm>
            <a:off x="4587949" y="804297"/>
            <a:ext cx="1224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r</a:t>
            </a:r>
            <a:r>
              <a:rPr lang="en-US" sz="1400" b="1" baseline="30000" dirty="0"/>
              <a:t>2</a:t>
            </a:r>
            <a:r>
              <a:rPr lang="en-US" sz="1400" b="1" dirty="0"/>
              <a:t> = 0.0214</a:t>
            </a:r>
          </a:p>
          <a:p>
            <a:r>
              <a:rPr lang="en-US" sz="1400" b="1" dirty="0"/>
              <a:t>p =  0.538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F4CE8BC-E108-492F-BD07-4F1443671E89}"/>
              </a:ext>
            </a:extLst>
          </p:cNvPr>
          <p:cNvSpPr txBox="1"/>
          <p:nvPr/>
        </p:nvSpPr>
        <p:spPr>
          <a:xfrm>
            <a:off x="8660013" y="804297"/>
            <a:ext cx="1224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r</a:t>
            </a:r>
            <a:r>
              <a:rPr lang="en-US" sz="1400" b="1" baseline="30000" dirty="0"/>
              <a:t>2</a:t>
            </a:r>
            <a:r>
              <a:rPr lang="en-US" sz="1400" b="1" dirty="0"/>
              <a:t> = 0.0125</a:t>
            </a:r>
          </a:p>
          <a:p>
            <a:r>
              <a:rPr lang="en-US" sz="1400" b="1" dirty="0"/>
              <a:t>p =  0.6389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F4CE8BC-E108-492F-BD07-4F1443671E89}"/>
              </a:ext>
            </a:extLst>
          </p:cNvPr>
          <p:cNvSpPr txBox="1"/>
          <p:nvPr/>
        </p:nvSpPr>
        <p:spPr>
          <a:xfrm>
            <a:off x="965645" y="3522913"/>
            <a:ext cx="1224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r</a:t>
            </a:r>
            <a:r>
              <a:rPr lang="en-US" sz="1400" b="1" baseline="30000" dirty="0"/>
              <a:t>2</a:t>
            </a:r>
            <a:r>
              <a:rPr lang="en-US" sz="1400" b="1" dirty="0"/>
              <a:t> = 0.3487</a:t>
            </a:r>
          </a:p>
          <a:p>
            <a:r>
              <a:rPr lang="en-US" sz="1400" b="1" dirty="0"/>
              <a:t>p =  0.020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F4CE8BC-E108-492F-BD07-4F1443671E89}"/>
              </a:ext>
            </a:extLst>
          </p:cNvPr>
          <p:cNvSpPr txBox="1"/>
          <p:nvPr/>
        </p:nvSpPr>
        <p:spPr>
          <a:xfrm>
            <a:off x="4612803" y="3508972"/>
            <a:ext cx="1224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r</a:t>
            </a:r>
            <a:r>
              <a:rPr lang="en-US" sz="1400" b="1" baseline="30000" dirty="0"/>
              <a:t>2</a:t>
            </a:r>
            <a:r>
              <a:rPr lang="en-US" sz="1400" b="1" dirty="0"/>
              <a:t> = 0.2233</a:t>
            </a:r>
          </a:p>
          <a:p>
            <a:r>
              <a:rPr lang="en-US" sz="1400" b="1" dirty="0"/>
              <a:t>p =  0.0354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F4CE8BC-E108-492F-BD07-4F1443671E89}"/>
              </a:ext>
            </a:extLst>
          </p:cNvPr>
          <p:cNvSpPr txBox="1"/>
          <p:nvPr/>
        </p:nvSpPr>
        <p:spPr>
          <a:xfrm>
            <a:off x="8666572" y="3463966"/>
            <a:ext cx="1224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r</a:t>
            </a:r>
            <a:r>
              <a:rPr lang="en-US" sz="1400" b="1" baseline="30000" dirty="0"/>
              <a:t>2</a:t>
            </a:r>
            <a:r>
              <a:rPr lang="en-US" sz="1400" b="1" dirty="0"/>
              <a:t> = 0.5380</a:t>
            </a:r>
          </a:p>
          <a:p>
            <a:r>
              <a:rPr lang="en-US" sz="1400" b="1" dirty="0"/>
              <a:t>p =  0.000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D0C96D4-38A8-422E-8D75-8F23E8AA1F56}"/>
              </a:ext>
            </a:extLst>
          </p:cNvPr>
          <p:cNvSpPr txBox="1"/>
          <p:nvPr/>
        </p:nvSpPr>
        <p:spPr>
          <a:xfrm>
            <a:off x="390539" y="119274"/>
            <a:ext cx="3214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upplementary Figure 10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AC427A6-CCED-488F-A9C9-66F9D5BDF8B0}"/>
              </a:ext>
            </a:extLst>
          </p:cNvPr>
          <p:cNvSpPr txBox="1"/>
          <p:nvPr/>
        </p:nvSpPr>
        <p:spPr>
          <a:xfrm>
            <a:off x="568712" y="506052"/>
            <a:ext cx="30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8EBD9D0-0BB7-4DAC-AFA2-03990970CC21}"/>
              </a:ext>
            </a:extLst>
          </p:cNvPr>
          <p:cNvSpPr txBox="1"/>
          <p:nvPr/>
        </p:nvSpPr>
        <p:spPr>
          <a:xfrm>
            <a:off x="4159405" y="506052"/>
            <a:ext cx="30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57EFD5F-51FB-4B77-93A7-A57ED023D99F}"/>
              </a:ext>
            </a:extLst>
          </p:cNvPr>
          <p:cNvSpPr txBox="1"/>
          <p:nvPr/>
        </p:nvSpPr>
        <p:spPr>
          <a:xfrm>
            <a:off x="8329961" y="506052"/>
            <a:ext cx="30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32181F8-10AE-4D86-B350-FFA6696737A6}"/>
              </a:ext>
            </a:extLst>
          </p:cNvPr>
          <p:cNvSpPr txBox="1"/>
          <p:nvPr/>
        </p:nvSpPr>
        <p:spPr>
          <a:xfrm>
            <a:off x="568712" y="3349613"/>
            <a:ext cx="30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5E553AD-0F43-48D2-9F47-5D8139635AB6}"/>
              </a:ext>
            </a:extLst>
          </p:cNvPr>
          <p:cNvSpPr txBox="1"/>
          <p:nvPr/>
        </p:nvSpPr>
        <p:spPr>
          <a:xfrm>
            <a:off x="4159405" y="3349613"/>
            <a:ext cx="30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0DD253A-6C01-4E3B-9C98-313508D9EAEA}"/>
              </a:ext>
            </a:extLst>
          </p:cNvPr>
          <p:cNvSpPr txBox="1"/>
          <p:nvPr/>
        </p:nvSpPr>
        <p:spPr>
          <a:xfrm>
            <a:off x="8329961" y="3349613"/>
            <a:ext cx="30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248458401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583961" y="662813"/>
            <a:ext cx="339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868372" y="662813"/>
            <a:ext cx="339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90199" y="157891"/>
            <a:ext cx="3214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upplementary Figure 11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B41BF9F7-0F20-49D5-B51F-F893B7B50F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5882786"/>
              </p:ext>
            </p:extLst>
          </p:nvPr>
        </p:nvGraphicFramePr>
        <p:xfrm>
          <a:off x="5737473" y="1032145"/>
          <a:ext cx="4452196" cy="44521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6" name="Acrobat Document" r:id="rId4" imgW="3200301" imgH="3200400" progId="Acrobat.Document.DC">
                  <p:embed/>
                </p:oleObj>
              </mc:Choice>
              <mc:Fallback>
                <p:oleObj name="Acrobat Document" r:id="rId4" imgW="3200301" imgH="3200400" progId="Acrobat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737473" y="1032145"/>
                        <a:ext cx="4452196" cy="44521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" name="Picture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6021" y="1102374"/>
            <a:ext cx="4384906" cy="43819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283780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095028" y="668781"/>
            <a:ext cx="339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095028" y="3333048"/>
            <a:ext cx="339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537573" y="668781"/>
            <a:ext cx="339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537573" y="3333048"/>
            <a:ext cx="339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800922" y="668781"/>
            <a:ext cx="339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800922" y="3333048"/>
            <a:ext cx="339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90199" y="157891"/>
            <a:ext cx="3214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upplementary Figure 12</a:t>
            </a:r>
          </a:p>
        </p:txBody>
      </p:sp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7932460"/>
              </p:ext>
            </p:extLst>
          </p:nvPr>
        </p:nvGraphicFramePr>
        <p:xfrm>
          <a:off x="1310029" y="802620"/>
          <a:ext cx="2894855" cy="2461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46" name="Prism 9" r:id="rId4" imgW="4957745" imgH="4957473" progId="Prism9.Document">
                  <p:embed/>
                </p:oleObj>
              </mc:Choice>
              <mc:Fallback>
                <p:oleObj name="Prism 9" r:id="rId4" imgW="4957745" imgH="495747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310029" y="802620"/>
                        <a:ext cx="2894855" cy="2461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7968464"/>
              </p:ext>
            </p:extLst>
          </p:nvPr>
        </p:nvGraphicFramePr>
        <p:xfrm>
          <a:off x="4785607" y="802620"/>
          <a:ext cx="2885784" cy="24750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47" name="Prism 9" r:id="rId6" imgW="4877126" imgH="4957473" progId="Prism9.Document">
                  <p:embed/>
                </p:oleObj>
              </mc:Choice>
              <mc:Fallback>
                <p:oleObj name="Prism 9" r:id="rId6" imgW="4877126" imgH="495747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785607" y="802620"/>
                        <a:ext cx="2885784" cy="24750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6772958"/>
              </p:ext>
            </p:extLst>
          </p:nvPr>
        </p:nvGraphicFramePr>
        <p:xfrm>
          <a:off x="8036580" y="802620"/>
          <a:ext cx="2813946" cy="24750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48" name="Prism 9" r:id="rId8" imgW="5437864" imgH="4957473" progId="Prism9.Document">
                  <p:embed/>
                </p:oleObj>
              </mc:Choice>
              <mc:Fallback>
                <p:oleObj name="Prism 9" r:id="rId8" imgW="5437864" imgH="495747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036580" y="802620"/>
                        <a:ext cx="2813946" cy="24750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5807525"/>
              </p:ext>
            </p:extLst>
          </p:nvPr>
        </p:nvGraphicFramePr>
        <p:xfrm>
          <a:off x="1310029" y="3683553"/>
          <a:ext cx="2980987" cy="27537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49" name="Prism 9" r:id="rId10" imgW="5544397" imgH="4952793" progId="Prism9.Document">
                  <p:embed/>
                </p:oleObj>
              </mc:Choice>
              <mc:Fallback>
                <p:oleObj name="Prism 9" r:id="rId10" imgW="5544397" imgH="495279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310029" y="3683553"/>
                        <a:ext cx="2980987" cy="27537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1892782"/>
              </p:ext>
            </p:extLst>
          </p:nvPr>
        </p:nvGraphicFramePr>
        <p:xfrm>
          <a:off x="4785607" y="3677904"/>
          <a:ext cx="3040506" cy="27594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50" name="Prism 9" r:id="rId12" imgW="5107108" imgH="4952793" progId="Prism9.Document">
                  <p:embed/>
                </p:oleObj>
              </mc:Choice>
              <mc:Fallback>
                <p:oleObj name="Prism 9" r:id="rId12" imgW="5107108" imgH="495279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785607" y="3677904"/>
                        <a:ext cx="3040506" cy="27594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4683036"/>
              </p:ext>
            </p:extLst>
          </p:nvPr>
        </p:nvGraphicFramePr>
        <p:xfrm>
          <a:off x="8036580" y="3666535"/>
          <a:ext cx="3082266" cy="27707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451" name="Prism 9" r:id="rId14" imgW="5509486" imgH="4952793" progId="Prism9.Document">
                  <p:embed/>
                </p:oleObj>
              </mc:Choice>
              <mc:Fallback>
                <p:oleObj name="Prism 9" r:id="rId14" imgW="5509486" imgH="495279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8036580" y="3666535"/>
                        <a:ext cx="3082266" cy="27707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349879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64294" y="129872"/>
            <a:ext cx="3162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upplementary Figure 2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/>
        </p:nvGraphicFramePr>
        <p:xfrm>
          <a:off x="754063" y="1730375"/>
          <a:ext cx="3381375" cy="3097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1" name="Prism 8" r:id="rId3" imgW="3480712" imgH="3187137" progId="Prism8.Document">
                  <p:embed/>
                </p:oleObj>
              </mc:Choice>
              <mc:Fallback>
                <p:oleObj name="Prism 8" r:id="rId3" imgW="3480712" imgH="318713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54063" y="1730375"/>
                        <a:ext cx="3381375" cy="3097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/>
        </p:nvGraphicFramePr>
        <p:xfrm>
          <a:off x="4468813" y="1730375"/>
          <a:ext cx="3389312" cy="3095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2" name="Prism 8" r:id="rId5" imgW="3488400" imgH="3186360" progId="Prism8.Document">
                  <p:embed/>
                </p:oleObj>
              </mc:Choice>
              <mc:Fallback>
                <p:oleObj name="Prism 8" r:id="rId5" imgW="3488400" imgH="318636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468813" y="1730375"/>
                        <a:ext cx="3389312" cy="3095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/>
        </p:nvGraphicFramePr>
        <p:xfrm>
          <a:off x="8178800" y="1730375"/>
          <a:ext cx="3398838" cy="3095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3" name="Prism 8" r:id="rId7" imgW="3497400" imgH="3186360" progId="Prism8.Document">
                  <p:embed/>
                </p:oleObj>
              </mc:Choice>
              <mc:Fallback>
                <p:oleObj name="Prism 8" r:id="rId7" imgW="3497400" imgH="318636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178800" y="1730375"/>
                        <a:ext cx="3398838" cy="3095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495347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45883" y="117598"/>
            <a:ext cx="3162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upplementary Figure 3</a:t>
            </a: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/>
        </p:nvGraphicFramePr>
        <p:xfrm>
          <a:off x="2397125" y="1579563"/>
          <a:ext cx="7796742" cy="3659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1" name="Prism 8" r:id="rId3" imgW="5099882" imgH="2508808" progId="Prism8.Document">
                  <p:embed/>
                </p:oleObj>
              </mc:Choice>
              <mc:Fallback>
                <p:oleObj name="Prism 8" r:id="rId3" imgW="5099882" imgH="250880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97125" y="1579563"/>
                        <a:ext cx="7796742" cy="3659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552789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/>
        </p:nvGraphicFramePr>
        <p:xfrm>
          <a:off x="2602468" y="3260413"/>
          <a:ext cx="1419225" cy="1127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42" name="Prism 8" r:id="rId3" imgW="3809876" imgH="3027815" progId="Prism8.Document">
                  <p:embed/>
                </p:oleObj>
              </mc:Choice>
              <mc:Fallback>
                <p:oleObj name="Prism 8" r:id="rId3" imgW="3809876" imgH="30278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02468" y="3260413"/>
                        <a:ext cx="1419225" cy="1127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/>
        </p:nvGraphicFramePr>
        <p:xfrm>
          <a:off x="750888" y="1446213"/>
          <a:ext cx="1419225" cy="1193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43" name="Prism 8" r:id="rId5" imgW="3809876" imgH="3201769" progId="Prism8.Document">
                  <p:embed/>
                </p:oleObj>
              </mc:Choice>
              <mc:Fallback>
                <p:oleObj name="Prism 8" r:id="rId5" imgW="3809876" imgH="320176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50888" y="1446213"/>
                        <a:ext cx="1419225" cy="1193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/>
        </p:nvGraphicFramePr>
        <p:xfrm>
          <a:off x="2598738" y="1446213"/>
          <a:ext cx="1425575" cy="1196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44" name="Prism 8" r:id="rId7" imgW="3824392" imgH="3215464" progId="Prism8.Document">
                  <p:embed/>
                </p:oleObj>
              </mc:Choice>
              <mc:Fallback>
                <p:oleObj name="Prism 8" r:id="rId7" imgW="3824392" imgH="321546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598738" y="1446213"/>
                        <a:ext cx="1425575" cy="1196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/>
        </p:nvGraphicFramePr>
        <p:xfrm>
          <a:off x="752476" y="3241999"/>
          <a:ext cx="1417637" cy="1127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45" name="Prism 8" r:id="rId9" imgW="3809876" imgH="3027815" progId="Prism8.Document">
                  <p:embed/>
                </p:oleObj>
              </mc:Choice>
              <mc:Fallback>
                <p:oleObj name="Prism 8" r:id="rId9" imgW="3809876" imgH="30278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52476" y="3241999"/>
                        <a:ext cx="1417637" cy="1127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/>
        </p:nvGraphicFramePr>
        <p:xfrm>
          <a:off x="6190496" y="3241999"/>
          <a:ext cx="1441450" cy="1211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46" name="Prism 8" r:id="rId11" imgW="3809876" imgH="3201769" progId="Prism8.Document">
                  <p:embed/>
                </p:oleObj>
              </mc:Choice>
              <mc:Fallback>
                <p:oleObj name="Prism 8" r:id="rId11" imgW="3809876" imgH="320176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190496" y="3241999"/>
                        <a:ext cx="1441450" cy="1211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/>
        </p:nvGraphicFramePr>
        <p:xfrm>
          <a:off x="4338916" y="1440311"/>
          <a:ext cx="1439862" cy="1144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47" name="Prism 8" r:id="rId13" imgW="3809876" imgH="3027815" progId="Prism8.Document">
                  <p:embed/>
                </p:oleObj>
              </mc:Choice>
              <mc:Fallback>
                <p:oleObj name="Prism 8" r:id="rId13" imgW="3809876" imgH="30278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338916" y="1440311"/>
                        <a:ext cx="1439862" cy="1144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/>
        </p:nvGraphicFramePr>
        <p:xfrm>
          <a:off x="6190496" y="1443487"/>
          <a:ext cx="1441450" cy="1144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48" name="Prism 8" r:id="rId15" imgW="3809876" imgH="3027815" progId="Prism8.Document">
                  <p:embed/>
                </p:oleObj>
              </mc:Choice>
              <mc:Fallback>
                <p:oleObj name="Prism 8" r:id="rId15" imgW="3809876" imgH="30278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190496" y="1443487"/>
                        <a:ext cx="1441450" cy="1144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/>
        </p:nvGraphicFramePr>
        <p:xfrm>
          <a:off x="4338916" y="3260413"/>
          <a:ext cx="1439863" cy="1144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49" name="Prism 8" r:id="rId17" imgW="3809876" imgH="3027815" progId="Prism8.Document">
                  <p:embed/>
                </p:oleObj>
              </mc:Choice>
              <mc:Fallback>
                <p:oleObj name="Prism 8" r:id="rId17" imgW="3809876" imgH="30278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338916" y="3260413"/>
                        <a:ext cx="1439863" cy="1144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/>
        </p:nvGraphicFramePr>
        <p:xfrm>
          <a:off x="9875283" y="3260413"/>
          <a:ext cx="1444625" cy="1214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50" name="Prism 8" r:id="rId19" imgW="3809876" imgH="3201769" progId="Prism8.Document">
                  <p:embed/>
                </p:oleObj>
              </mc:Choice>
              <mc:Fallback>
                <p:oleObj name="Prism 8" r:id="rId19" imgW="3809876" imgH="320176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9875283" y="3260413"/>
                        <a:ext cx="1444625" cy="1214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/>
        </p:nvGraphicFramePr>
        <p:xfrm>
          <a:off x="8118198" y="1440311"/>
          <a:ext cx="1441450" cy="1147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51" name="Prism 8" r:id="rId21" imgW="3805194" imgH="3027815" progId="Prism8.Document">
                  <p:embed/>
                </p:oleObj>
              </mc:Choice>
              <mc:Fallback>
                <p:oleObj name="Prism 8" r:id="rId21" imgW="3805194" imgH="30278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8118198" y="1440311"/>
                        <a:ext cx="1441450" cy="1147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/>
        </p:nvGraphicFramePr>
        <p:xfrm>
          <a:off x="9875283" y="1447800"/>
          <a:ext cx="1444625" cy="1214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52" name="Prism 8" r:id="rId23" imgW="3809876" imgH="3201769" progId="Prism8.Document">
                  <p:embed/>
                </p:oleObj>
              </mc:Choice>
              <mc:Fallback>
                <p:oleObj name="Prism 8" r:id="rId23" imgW="3809876" imgH="320176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9875283" y="1447800"/>
                        <a:ext cx="1444625" cy="1214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/>
        </p:nvGraphicFramePr>
        <p:xfrm>
          <a:off x="8113435" y="3241999"/>
          <a:ext cx="1446213" cy="1214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553" name="Prism 8" r:id="rId25" imgW="3809876" imgH="3201769" progId="Prism8.Document">
                  <p:embed/>
                </p:oleObj>
              </mc:Choice>
              <mc:Fallback>
                <p:oleObj name="Prism 8" r:id="rId25" imgW="3809876" imgH="320176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8113435" y="3241999"/>
                        <a:ext cx="1446213" cy="1214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208898" y="225554"/>
            <a:ext cx="3162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upplementary Figure 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AA9A31-1C13-4DEE-BE5A-3A655739E312}"/>
              </a:ext>
            </a:extLst>
          </p:cNvPr>
          <p:cNvSpPr txBox="1"/>
          <p:nvPr/>
        </p:nvSpPr>
        <p:spPr>
          <a:xfrm>
            <a:off x="411772" y="1172693"/>
            <a:ext cx="396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DAA9A31-1C13-4DEE-BE5A-3A655739E312}"/>
              </a:ext>
            </a:extLst>
          </p:cNvPr>
          <p:cNvSpPr txBox="1"/>
          <p:nvPr/>
        </p:nvSpPr>
        <p:spPr>
          <a:xfrm>
            <a:off x="411771" y="2891081"/>
            <a:ext cx="396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933132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8697711"/>
              </p:ext>
            </p:extLst>
          </p:nvPr>
        </p:nvGraphicFramePr>
        <p:xfrm>
          <a:off x="1535617" y="1862885"/>
          <a:ext cx="1862137" cy="1931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66" name="Prism 9" r:id="rId3" imgW="2367532" imgH="2453009" progId="Prism9.Document">
                  <p:embed/>
                </p:oleObj>
              </mc:Choice>
              <mc:Fallback>
                <p:oleObj name="Prism 9" r:id="rId3" imgW="2367532" imgH="245300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35617" y="1862885"/>
                        <a:ext cx="1862137" cy="1931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0354921"/>
              </p:ext>
            </p:extLst>
          </p:nvPr>
        </p:nvGraphicFramePr>
        <p:xfrm>
          <a:off x="4859918" y="1893149"/>
          <a:ext cx="1869409" cy="19017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67" name="Prism 9" r:id="rId5" imgW="2436318" imgH="2478940" progId="Prism9.Document">
                  <p:embed/>
                </p:oleObj>
              </mc:Choice>
              <mc:Fallback>
                <p:oleObj name="Prism 9" r:id="rId5" imgW="2436318" imgH="247894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59918" y="1893149"/>
                        <a:ext cx="1869409" cy="19017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381559" y="1523891"/>
            <a:ext cx="396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800635" y="1523891"/>
            <a:ext cx="396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116503" y="3810700"/>
            <a:ext cx="20667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TK WT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287834" y="3810700"/>
            <a:ext cx="2224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TK C481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08898" y="225554"/>
            <a:ext cx="3162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31055707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3259" y="297914"/>
            <a:ext cx="2803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upplementary Figure 6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975754" y="2854867"/>
            <a:ext cx="1704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pleen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/>
        </p:nvGraphicFramePr>
        <p:xfrm>
          <a:off x="5789465" y="2364657"/>
          <a:ext cx="2595563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20" name="Prism 8" r:id="rId3" imgW="4059810" imgH="2508808" progId="Prism8.Document">
                  <p:embed/>
                </p:oleObj>
              </mc:Choice>
              <mc:Fallback>
                <p:oleObj name="Prism 8" r:id="rId3" imgW="4059810" imgH="250880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789465" y="2364657"/>
                        <a:ext cx="2595563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/>
        </p:nvGraphicFramePr>
        <p:xfrm>
          <a:off x="2754137" y="2364657"/>
          <a:ext cx="2557462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21" name="Prism 8" r:id="rId5" imgW="4059810" imgH="2508808" progId="Prism8.Document">
                  <p:embed/>
                </p:oleObj>
              </mc:Choice>
              <mc:Fallback>
                <p:oleObj name="Prism 8" r:id="rId5" imgW="4059810" imgH="250880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754137" y="2364657"/>
                        <a:ext cx="2557462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TextBox 28"/>
          <p:cNvSpPr txBox="1"/>
          <p:nvPr/>
        </p:nvSpPr>
        <p:spPr>
          <a:xfrm>
            <a:off x="2788210" y="1937905"/>
            <a:ext cx="396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5772301" y="1937905"/>
            <a:ext cx="396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cxnSp>
        <p:nvCxnSpPr>
          <p:cNvPr id="10" name="Straight Connector 9"/>
          <p:cNvCxnSpPr/>
          <p:nvPr/>
        </p:nvCxnSpPr>
        <p:spPr>
          <a:xfrm>
            <a:off x="2590800" y="1937905"/>
            <a:ext cx="0" cy="215149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18303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8898" y="225554"/>
            <a:ext cx="3162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upplementary Figure 7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244830" y="1975359"/>
            <a:ext cx="9809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TK </a:t>
            </a:r>
          </a:p>
          <a:p>
            <a:r>
              <a:rPr lang="en-US" dirty="0"/>
              <a:t>WT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075308" y="4839304"/>
            <a:ext cx="9809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TK C481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AC00FA-1689-41D5-AD96-7840FDC7062B}"/>
              </a:ext>
            </a:extLst>
          </p:cNvPr>
          <p:cNvSpPr txBox="1"/>
          <p:nvPr/>
        </p:nvSpPr>
        <p:spPr>
          <a:xfrm>
            <a:off x="6945892" y="1223198"/>
            <a:ext cx="1599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ne Marrow</a:t>
            </a: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/>
        </p:nvGraphicFramePr>
        <p:xfrm>
          <a:off x="3237207" y="1460094"/>
          <a:ext cx="2006031" cy="20111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70" name="Prism 8" r:id="rId3" imgW="2498848" imgH="2505556" progId="Prism8.Document">
                  <p:embed/>
                </p:oleObj>
              </mc:Choice>
              <mc:Fallback>
                <p:oleObj name="Prism 8" r:id="rId3" imgW="2498848" imgH="250555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37207" y="1460094"/>
                        <a:ext cx="2006031" cy="20111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/>
        </p:nvGraphicFramePr>
        <p:xfrm>
          <a:off x="6368877" y="1559136"/>
          <a:ext cx="1907240" cy="1912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71" name="Prism 8" r:id="rId5" imgW="2498848" imgH="2505556" progId="Prism8.Document">
                  <p:embed/>
                </p:oleObj>
              </mc:Choice>
              <mc:Fallback>
                <p:oleObj name="Prism 8" r:id="rId5" imgW="2498848" imgH="250555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368877" y="1559136"/>
                        <a:ext cx="1907240" cy="1912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/>
        </p:nvGraphicFramePr>
        <p:xfrm>
          <a:off x="3158164" y="4302607"/>
          <a:ext cx="2057320" cy="19759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72" name="Prism 8" r:id="rId7" imgW="2608260" imgH="2505556" progId="Prism8.Document">
                  <p:embed/>
                </p:oleObj>
              </mc:Choice>
              <mc:Fallback>
                <p:oleObj name="Prism 8" r:id="rId7" imgW="2608260" imgH="250555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158164" y="4302607"/>
                        <a:ext cx="2057320" cy="19759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/>
        </p:nvGraphicFramePr>
        <p:xfrm>
          <a:off x="6384257" y="4302607"/>
          <a:ext cx="1970919" cy="19759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73" name="Prism 8" r:id="rId9" imgW="2498848" imgH="2505556" progId="Prism8.Document">
                  <p:embed/>
                </p:oleObj>
              </mc:Choice>
              <mc:Fallback>
                <p:oleObj name="Prism 8" r:id="rId9" imgW="2498848" imgH="250555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384257" y="4302607"/>
                        <a:ext cx="1970919" cy="19759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3040126" y="881017"/>
            <a:ext cx="396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040126" y="3740826"/>
            <a:ext cx="396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600274" y="875476"/>
            <a:ext cx="396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409362" y="3745639"/>
            <a:ext cx="396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E16D7DE-3ABA-47EF-AAFE-D743C652A5D7}"/>
              </a:ext>
            </a:extLst>
          </p:cNvPr>
          <p:cNvSpPr txBox="1"/>
          <p:nvPr/>
        </p:nvSpPr>
        <p:spPr>
          <a:xfrm>
            <a:off x="4041587" y="1182021"/>
            <a:ext cx="11067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pleen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3963108" y="1536737"/>
            <a:ext cx="10858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V="1">
            <a:off x="6960112" y="1554449"/>
            <a:ext cx="1498600" cy="63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2796214" y="1460094"/>
            <a:ext cx="0" cy="191175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2796214" y="4302607"/>
            <a:ext cx="0" cy="185689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434818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1833799"/>
              </p:ext>
            </p:extLst>
          </p:nvPr>
        </p:nvGraphicFramePr>
        <p:xfrm>
          <a:off x="306070" y="917111"/>
          <a:ext cx="3778250" cy="269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434" name="Prism 9" r:id="rId4" imgW="3777824" imgH="2698634" progId="Prism9.Document">
                  <p:embed/>
                </p:oleObj>
              </mc:Choice>
              <mc:Fallback>
                <p:oleObj name="Prism 9" r:id="rId4" imgW="3777824" imgH="2698634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06070" y="917111"/>
                        <a:ext cx="3778250" cy="269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3251130"/>
              </p:ext>
            </p:extLst>
          </p:nvPr>
        </p:nvGraphicFramePr>
        <p:xfrm>
          <a:off x="304040" y="3564942"/>
          <a:ext cx="3778250" cy="27199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435" name="Prism 9" r:id="rId6" imgW="3777824" imgH="2698634" progId="Prism9.Document">
                  <p:embed/>
                </p:oleObj>
              </mc:Choice>
              <mc:Fallback>
                <p:oleObj name="Prism 9" r:id="rId6" imgW="3777824" imgH="2698634" progId="Prism9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04040" y="3564942"/>
                        <a:ext cx="3778250" cy="27199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6294777"/>
              </p:ext>
            </p:extLst>
          </p:nvPr>
        </p:nvGraphicFramePr>
        <p:xfrm>
          <a:off x="4160838" y="3575050"/>
          <a:ext cx="3778250" cy="2700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436" name="Prism 9" r:id="rId8" imgW="3777824" imgH="2707638" progId="Prism9.Document">
                  <p:embed/>
                </p:oleObj>
              </mc:Choice>
              <mc:Fallback>
                <p:oleObj name="Prism 9" r:id="rId8" imgW="3777824" imgH="2707638" progId="Prism9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160838" y="3575050"/>
                        <a:ext cx="3778250" cy="2700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8981224"/>
              </p:ext>
            </p:extLst>
          </p:nvPr>
        </p:nvGraphicFramePr>
        <p:xfrm>
          <a:off x="8022908" y="3564943"/>
          <a:ext cx="3778250" cy="27199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437" name="Prism 9" r:id="rId10" imgW="3777824" imgH="2698634" progId="Prism9.Document">
                  <p:embed/>
                </p:oleObj>
              </mc:Choice>
              <mc:Fallback>
                <p:oleObj name="Prism 9" r:id="rId10" imgW="3777824" imgH="2698634" progId="Prism9.Document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022908" y="3564943"/>
                        <a:ext cx="3778250" cy="27199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23E98ED7-3FD1-4ADE-984F-AE2C3B99829D}"/>
              </a:ext>
            </a:extLst>
          </p:cNvPr>
          <p:cNvSpPr txBox="1"/>
          <p:nvPr/>
        </p:nvSpPr>
        <p:spPr>
          <a:xfrm>
            <a:off x="872447" y="1115067"/>
            <a:ext cx="12491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r</a:t>
            </a:r>
            <a:r>
              <a:rPr lang="en-US" sz="1400" b="1" baseline="30000" dirty="0"/>
              <a:t>2</a:t>
            </a:r>
            <a:r>
              <a:rPr lang="en-US" sz="1400" b="1" dirty="0"/>
              <a:t> = 0.1222</a:t>
            </a:r>
          </a:p>
          <a:p>
            <a:r>
              <a:rPr lang="en-US" sz="1400" b="1" dirty="0"/>
              <a:t>p =  0.1550</a:t>
            </a:r>
          </a:p>
        </p:txBody>
      </p:sp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D20255CB-A7DC-45DE-9FC5-5FDCEEEE725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1952138"/>
              </p:ext>
            </p:extLst>
          </p:nvPr>
        </p:nvGraphicFramePr>
        <p:xfrm>
          <a:off x="4162459" y="914730"/>
          <a:ext cx="3781583" cy="27011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438" name="Prism 9" r:id="rId12" imgW="3777824" imgH="2698634" progId="Prism9.Document">
                  <p:embed/>
                </p:oleObj>
              </mc:Choice>
              <mc:Fallback>
                <p:oleObj name="Prism 9" r:id="rId12" imgW="3777824" imgH="2698634" progId="Prism9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D20255CB-A7DC-45DE-9FC5-5FDCEEEE725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162459" y="914730"/>
                        <a:ext cx="3781583" cy="27011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53DCC415-C147-4DCF-8DF3-4458C88B5EA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6051036"/>
              </p:ext>
            </p:extLst>
          </p:nvPr>
        </p:nvGraphicFramePr>
        <p:xfrm>
          <a:off x="8022908" y="917111"/>
          <a:ext cx="3778250" cy="269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439" name="Prism 9" r:id="rId14" imgW="3777824" imgH="2698634" progId="Prism9.Document">
                  <p:embed/>
                </p:oleObj>
              </mc:Choice>
              <mc:Fallback>
                <p:oleObj name="Prism 9" r:id="rId14" imgW="3777824" imgH="2698634" progId="Prism9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53DCC415-C147-4DCF-8DF3-4458C88B5EA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8022908" y="917111"/>
                        <a:ext cx="3778250" cy="269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23E98ED7-3FD1-4ADE-984F-AE2C3B99829D}"/>
              </a:ext>
            </a:extLst>
          </p:cNvPr>
          <p:cNvSpPr txBox="1"/>
          <p:nvPr/>
        </p:nvSpPr>
        <p:spPr>
          <a:xfrm>
            <a:off x="4705645" y="1115067"/>
            <a:ext cx="12491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r</a:t>
            </a:r>
            <a:r>
              <a:rPr lang="en-US" sz="1400" b="1" baseline="30000" dirty="0"/>
              <a:t>2</a:t>
            </a:r>
            <a:r>
              <a:rPr lang="en-US" sz="1400" b="1" dirty="0"/>
              <a:t> = 0.0319</a:t>
            </a:r>
          </a:p>
          <a:p>
            <a:r>
              <a:rPr lang="en-US" sz="1400" b="1" dirty="0"/>
              <a:t>p =  0.451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3E98ED7-3FD1-4ADE-984F-AE2C3B99829D}"/>
              </a:ext>
            </a:extLst>
          </p:cNvPr>
          <p:cNvSpPr txBox="1"/>
          <p:nvPr/>
        </p:nvSpPr>
        <p:spPr>
          <a:xfrm>
            <a:off x="8566959" y="1089310"/>
            <a:ext cx="12491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r</a:t>
            </a:r>
            <a:r>
              <a:rPr lang="en-US" sz="1400" b="1" baseline="30000" dirty="0"/>
              <a:t>2</a:t>
            </a:r>
            <a:r>
              <a:rPr lang="en-US" sz="1400" b="1" dirty="0"/>
              <a:t> = 0.0021</a:t>
            </a:r>
          </a:p>
          <a:p>
            <a:r>
              <a:rPr lang="en-US" sz="1400" b="1" dirty="0"/>
              <a:t>p =  0.849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3E98ED7-3FD1-4ADE-984F-AE2C3B99829D}"/>
              </a:ext>
            </a:extLst>
          </p:cNvPr>
          <p:cNvSpPr txBox="1"/>
          <p:nvPr/>
        </p:nvSpPr>
        <p:spPr>
          <a:xfrm>
            <a:off x="853885" y="3683507"/>
            <a:ext cx="12491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r</a:t>
            </a:r>
            <a:r>
              <a:rPr lang="en-US" sz="1400" b="1" baseline="30000" dirty="0"/>
              <a:t>2</a:t>
            </a:r>
            <a:r>
              <a:rPr lang="en-US" sz="1400" b="1" dirty="0"/>
              <a:t> = 0.4232</a:t>
            </a:r>
          </a:p>
          <a:p>
            <a:r>
              <a:rPr lang="en-US" sz="1400" b="1" dirty="0"/>
              <a:t>p =  0.008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3E98ED7-3FD1-4ADE-984F-AE2C3B99829D}"/>
              </a:ext>
            </a:extLst>
          </p:cNvPr>
          <p:cNvSpPr txBox="1"/>
          <p:nvPr/>
        </p:nvSpPr>
        <p:spPr>
          <a:xfrm>
            <a:off x="4712087" y="3691330"/>
            <a:ext cx="12491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r</a:t>
            </a:r>
            <a:r>
              <a:rPr lang="en-US" sz="1400" b="1" baseline="30000" dirty="0"/>
              <a:t>2</a:t>
            </a:r>
            <a:r>
              <a:rPr lang="en-US" sz="1400" b="1" dirty="0"/>
              <a:t> = 0.1579</a:t>
            </a:r>
          </a:p>
          <a:p>
            <a:r>
              <a:rPr lang="en-US" sz="1400" b="1" dirty="0"/>
              <a:t>p =  0.082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3E98ED7-3FD1-4ADE-984F-AE2C3B99829D}"/>
              </a:ext>
            </a:extLst>
          </p:cNvPr>
          <p:cNvSpPr txBox="1"/>
          <p:nvPr/>
        </p:nvSpPr>
        <p:spPr>
          <a:xfrm>
            <a:off x="8564636" y="3786536"/>
            <a:ext cx="12491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r</a:t>
            </a:r>
            <a:r>
              <a:rPr lang="en-US" sz="1400" b="1" baseline="30000" dirty="0"/>
              <a:t>2</a:t>
            </a:r>
            <a:r>
              <a:rPr lang="en-US" sz="1400" b="1" dirty="0"/>
              <a:t> = 0.4849</a:t>
            </a:r>
          </a:p>
          <a:p>
            <a:r>
              <a:rPr lang="en-US" sz="1400" b="1" dirty="0"/>
              <a:t>p =  0.000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6F7F7CC-F143-4454-BDB7-C01A1B93B401}"/>
              </a:ext>
            </a:extLst>
          </p:cNvPr>
          <p:cNvSpPr txBox="1"/>
          <p:nvPr/>
        </p:nvSpPr>
        <p:spPr>
          <a:xfrm>
            <a:off x="514533" y="10864"/>
            <a:ext cx="3214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upplementary Figure 8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7302765-425B-46B6-BB12-721EF15F0059}"/>
              </a:ext>
            </a:extLst>
          </p:cNvPr>
          <p:cNvSpPr txBox="1"/>
          <p:nvPr/>
        </p:nvSpPr>
        <p:spPr>
          <a:xfrm>
            <a:off x="568712" y="506052"/>
            <a:ext cx="30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874B2DC-AC01-4E97-AF64-71AC2786DB64}"/>
              </a:ext>
            </a:extLst>
          </p:cNvPr>
          <p:cNvSpPr txBox="1"/>
          <p:nvPr/>
        </p:nvSpPr>
        <p:spPr>
          <a:xfrm>
            <a:off x="4159405" y="506052"/>
            <a:ext cx="30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620A1AF-6D70-4AA6-BC06-F09FF957875E}"/>
              </a:ext>
            </a:extLst>
          </p:cNvPr>
          <p:cNvSpPr txBox="1"/>
          <p:nvPr/>
        </p:nvSpPr>
        <p:spPr>
          <a:xfrm>
            <a:off x="8329961" y="506052"/>
            <a:ext cx="30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BA27FB9-8D3D-4392-9252-C5AD423EE6B8}"/>
              </a:ext>
            </a:extLst>
          </p:cNvPr>
          <p:cNvSpPr txBox="1"/>
          <p:nvPr/>
        </p:nvSpPr>
        <p:spPr>
          <a:xfrm>
            <a:off x="568712" y="3349613"/>
            <a:ext cx="30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5C71397-236B-4B4E-B68F-D380A957DFAB}"/>
              </a:ext>
            </a:extLst>
          </p:cNvPr>
          <p:cNvSpPr txBox="1"/>
          <p:nvPr/>
        </p:nvSpPr>
        <p:spPr>
          <a:xfrm>
            <a:off x="4159405" y="3349613"/>
            <a:ext cx="30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5B417B2-E6CA-4E8F-8F00-B4BEC4DE04D8}"/>
              </a:ext>
            </a:extLst>
          </p:cNvPr>
          <p:cNvSpPr txBox="1"/>
          <p:nvPr/>
        </p:nvSpPr>
        <p:spPr>
          <a:xfrm>
            <a:off x="8329961" y="3349613"/>
            <a:ext cx="30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286513274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906132" y="806746"/>
            <a:ext cx="339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868372" y="806746"/>
            <a:ext cx="339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90199" y="157891"/>
            <a:ext cx="3214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upplementary Figure 9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586" y="1515527"/>
            <a:ext cx="4376060" cy="4379018"/>
          </a:xfrm>
          <a:prstGeom prst="rect">
            <a:avLst/>
          </a:prstGeom>
        </p:spPr>
      </p:pic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4732C23B-6436-4F50-8587-C6321A7B46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9165159"/>
              </p:ext>
            </p:extLst>
          </p:nvPr>
        </p:nvGraphicFramePr>
        <p:xfrm>
          <a:off x="6335051" y="1515527"/>
          <a:ext cx="4452196" cy="44521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64" name="Acrobat Document" r:id="rId4" imgW="3200301" imgH="3200400" progId="Acrobat.Document.DC">
                  <p:embed/>
                </p:oleObj>
              </mc:Choice>
              <mc:Fallback>
                <p:oleObj name="Acrobat Document" r:id="rId4" imgW="3200301" imgH="3200400" progId="Acrobat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335051" y="1515527"/>
                        <a:ext cx="4452196" cy="44521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489767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5</TotalTime>
  <Words>156</Words>
  <Application>Microsoft Office PowerPoint</Application>
  <PresentationFormat>Widescreen</PresentationFormat>
  <Paragraphs>80</Paragraphs>
  <Slides>12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ial</vt:lpstr>
      <vt:lpstr>Calibri</vt:lpstr>
      <vt:lpstr>Calibri Light</vt:lpstr>
      <vt:lpstr>Office Theme</vt:lpstr>
      <vt:lpstr>Prism 8</vt:lpstr>
      <vt:lpstr>Prism 9</vt:lpstr>
      <vt:lpstr>Acrobat 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lan,Burcu</dc:creator>
  <cp:lastModifiedBy>Aslan,Burcu</cp:lastModifiedBy>
  <cp:revision>38</cp:revision>
  <dcterms:created xsi:type="dcterms:W3CDTF">2021-11-10T16:32:03Z</dcterms:created>
  <dcterms:modified xsi:type="dcterms:W3CDTF">2022-04-05T20:55:20Z</dcterms:modified>
</cp:coreProperties>
</file>